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1854" autoAdjust="0"/>
  </p:normalViewPr>
  <p:slideViewPr>
    <p:cSldViewPr snapToGrid="0" snapToObjects="1">
      <p:cViewPr>
        <p:scale>
          <a:sx n="89" d="100"/>
          <a:sy n="89" d="100"/>
        </p:scale>
        <p:origin x="-3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C97A7A-7A2E-344B-BE84-79CA7B781979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51979-CDBD-F54A-B215-11E850204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43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1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3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5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44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6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0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5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43636" y="1769946"/>
            <a:ext cx="3711761" cy="5608315"/>
            <a:chOff x="3011432" y="3527765"/>
            <a:chExt cx="3711761" cy="5608315"/>
          </a:xfrm>
        </p:grpSpPr>
        <p:grpSp>
          <p:nvGrpSpPr>
            <p:cNvPr id="5" name="Group 4"/>
            <p:cNvGrpSpPr/>
            <p:nvPr/>
          </p:nvGrpSpPr>
          <p:grpSpPr>
            <a:xfrm>
              <a:off x="3191456" y="3651294"/>
              <a:ext cx="3343723" cy="2653834"/>
              <a:chOff x="1622002" y="3277674"/>
              <a:chExt cx="3343723" cy="2653834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2305258" y="3277674"/>
                <a:ext cx="2660467" cy="2653834"/>
                <a:chOff x="2338633" y="3451651"/>
                <a:chExt cx="2813660" cy="2828562"/>
              </a:xfrm>
            </p:grpSpPr>
            <p:sp>
              <p:nvSpPr>
                <p:cNvPr id="25" name="TextBox 24"/>
                <p:cNvSpPr txBox="1"/>
                <p:nvPr/>
              </p:nvSpPr>
              <p:spPr>
                <a:xfrm>
                  <a:off x="2338633" y="3451651"/>
                  <a:ext cx="1235727" cy="2624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Percent inhibition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312291" y="3451651"/>
                  <a:ext cx="571658" cy="2624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Arial"/>
                      <a:cs typeface="Arial"/>
                    </a:rPr>
                    <a:t>ΔBliss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407810" y="6050584"/>
                  <a:ext cx="1094121" cy="2296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/>
                    <a:t>FRAX1036 (</a:t>
                  </a:r>
                  <a:r>
                    <a:rPr lang="en-US" sz="800" dirty="0" err="1" smtClean="0"/>
                    <a:t>μM</a:t>
                  </a:r>
                  <a:r>
                    <a:rPr lang="en-US" sz="800" dirty="0" smtClean="0"/>
                    <a:t>)</a:t>
                  </a:r>
                  <a:endParaRPr lang="en-US" sz="800" dirty="0"/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4058172" y="6049988"/>
                  <a:ext cx="1094121" cy="2296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/>
                    <a:t>FRAX1036 (</a:t>
                  </a:r>
                  <a:r>
                    <a:rPr lang="en-US" sz="800" dirty="0" err="1" smtClean="0"/>
                    <a:t>μM</a:t>
                  </a:r>
                  <a:r>
                    <a:rPr lang="en-US" sz="800" dirty="0" smtClean="0"/>
                    <a:t>)</a:t>
                  </a:r>
                  <a:endParaRPr lang="en-US" sz="800" dirty="0"/>
                </a:p>
              </p:txBody>
            </p:sp>
          </p:grpSp>
          <p:sp>
            <p:nvSpPr>
              <p:cNvPr id="24" name="TextBox 23"/>
              <p:cNvSpPr txBox="1"/>
              <p:nvPr/>
            </p:nvSpPr>
            <p:spPr>
              <a:xfrm rot="16200000">
                <a:off x="1334480" y="4309188"/>
                <a:ext cx="8212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/>
                  <a:t>DTX </a:t>
                </a:r>
                <a:r>
                  <a:rPr lang="en-US" sz="1000" dirty="0" smtClean="0"/>
                  <a:t>(</a:t>
                </a:r>
                <a:r>
                  <a:rPr lang="en-US" sz="800" dirty="0" err="1" smtClean="0"/>
                  <a:t>nM</a:t>
                </a:r>
                <a:r>
                  <a:rPr lang="en-US" sz="1000" dirty="0" smtClean="0"/>
                  <a:t>)</a:t>
                </a:r>
                <a:endParaRPr lang="en-US" sz="1000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3984588" y="6496314"/>
              <a:ext cx="11684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Percent inhibition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698451" y="6522908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ΔBliss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020038" y="8920636"/>
              <a:ext cx="10180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FRAX1036 (</a:t>
              </a:r>
              <a:r>
                <a:rPr lang="el-GR" sz="800" dirty="0" smtClean="0">
                  <a:latin typeface="Calibri"/>
                </a:rPr>
                <a:t>μ</a:t>
              </a:r>
              <a:r>
                <a:rPr lang="en-US" sz="800" dirty="0"/>
                <a:t>M</a:t>
              </a:r>
              <a:r>
                <a:rPr lang="en-US" sz="800" dirty="0" smtClean="0"/>
                <a:t>)</a:t>
              </a:r>
              <a:endParaRPr lang="en-US" sz="8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549620" y="8914172"/>
              <a:ext cx="10180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FRAX1036 (</a:t>
              </a:r>
              <a:r>
                <a:rPr lang="el-GR" sz="800" dirty="0" smtClean="0"/>
                <a:t>μ</a:t>
              </a:r>
              <a:r>
                <a:rPr lang="en-US" sz="800" smtClean="0"/>
                <a:t>M)</a:t>
              </a:r>
              <a:endParaRPr lang="en-US" sz="8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11432" y="352776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A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011432" y="636872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B</a:t>
              </a:r>
              <a:endParaRPr lang="en-US" b="1" dirty="0">
                <a:latin typeface="Arial"/>
                <a:cs typeface="Arial"/>
              </a:endParaRP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/>
            <a:srcRect b="7810"/>
            <a:stretch/>
          </p:blipFill>
          <p:spPr>
            <a:xfrm>
              <a:off x="5259002" y="6707949"/>
              <a:ext cx="1464191" cy="2052594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/>
            <a:srcRect b="8724"/>
            <a:stretch/>
          </p:blipFill>
          <p:spPr>
            <a:xfrm>
              <a:off x="5239688" y="3882304"/>
              <a:ext cx="1443251" cy="2059189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/>
            <a:srcRect l="16030" b="8683"/>
            <a:stretch/>
          </p:blipFill>
          <p:spPr>
            <a:xfrm>
              <a:off x="3692749" y="3871584"/>
              <a:ext cx="1473199" cy="2069909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3334105" y="3915161"/>
              <a:ext cx="470551" cy="26161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smtClean="0"/>
                <a:t>2.5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83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28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93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31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1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034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</a:t>
              </a:r>
            </a:p>
            <a:p>
              <a:pPr algn="r"/>
              <a:endParaRPr lang="en-US" sz="800" dirty="0" smtClean="0"/>
            </a:p>
            <a:p>
              <a:pPr algn="r"/>
              <a:endParaRPr lang="en-US" dirty="0"/>
            </a:p>
            <a:p>
              <a:pPr algn="r"/>
              <a:endParaRPr lang="en-US" dirty="0"/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/>
            <a:srcRect b="8423"/>
            <a:stretch/>
          </p:blipFill>
          <p:spPr>
            <a:xfrm>
              <a:off x="3709100" y="6681289"/>
              <a:ext cx="1539055" cy="2079253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3291307" y="6745390"/>
              <a:ext cx="518155" cy="20621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smtClean="0"/>
                <a:t>0.4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13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44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15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049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016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.00055</a:t>
              </a:r>
            </a:p>
            <a:p>
              <a:pPr algn="r"/>
              <a:endParaRPr lang="en-US" sz="800" dirty="0"/>
            </a:p>
            <a:p>
              <a:pPr algn="r"/>
              <a:r>
                <a:rPr lang="en-US" sz="800" dirty="0" smtClean="0"/>
                <a:t>0</a:t>
              </a:r>
            </a:p>
            <a:p>
              <a:pPr algn="r"/>
              <a:endParaRPr lang="en-US" sz="800" dirty="0" smtClean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882485" y="7459911"/>
              <a:ext cx="8212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/>
                <a:t>DTX </a:t>
              </a:r>
              <a:r>
                <a:rPr lang="en-US" sz="1000" dirty="0" smtClean="0"/>
                <a:t>(</a:t>
              </a:r>
              <a:r>
                <a:rPr lang="en-US" sz="800" dirty="0" err="1" smtClean="0"/>
                <a:t>nM</a:t>
              </a:r>
              <a:r>
                <a:rPr lang="en-US" sz="1000" dirty="0" smtClean="0"/>
                <a:t>)</a:t>
              </a:r>
              <a:endParaRPr lang="en-US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4266869" y="5314547"/>
              <a:ext cx="364202" cy="1438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3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5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88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1.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2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4.4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6.7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10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5771963" y="5311029"/>
              <a:ext cx="364202" cy="1438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3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5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88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1.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2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4.4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6.7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1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4313382" y="8087281"/>
              <a:ext cx="364202" cy="1554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.19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.29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.43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.65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0.98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1.5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2.2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 smtClean="0"/>
                <a:t>3.3</a:t>
              </a:r>
            </a:p>
            <a:p>
              <a:pPr algn="r">
                <a:spcBef>
                  <a:spcPts val="200"/>
                </a:spcBef>
              </a:pPr>
              <a:r>
                <a:rPr lang="en-US" sz="800" dirty="0"/>
                <a:t>5</a:t>
              </a:r>
              <a:endParaRPr lang="en-US" sz="800" dirty="0" smtClean="0"/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5814262" y="8141471"/>
              <a:ext cx="364202" cy="1438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1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29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4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65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0.98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1.5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2.2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 smtClean="0"/>
                <a:t>3.3</a:t>
              </a:r>
            </a:p>
            <a:p>
              <a:pPr algn="r">
                <a:spcBef>
                  <a:spcPts val="100"/>
                </a:spcBef>
              </a:pPr>
              <a:r>
                <a:rPr lang="en-US" sz="800" dirty="0"/>
                <a:t>5</a:t>
              </a:r>
              <a:endParaRPr lang="en-US" sz="800" dirty="0" smtClean="0"/>
            </a:p>
          </p:txBody>
        </p:sp>
      </p:grpSp>
      <p:sp>
        <p:nvSpPr>
          <p:cNvPr id="29" name="Title 1"/>
          <p:cNvSpPr>
            <a:spLocks noGrp="1"/>
          </p:cNvSpPr>
          <p:nvPr>
            <p:ph type="title"/>
          </p:nvPr>
        </p:nvSpPr>
        <p:spPr>
          <a:xfrm>
            <a:off x="103043" y="103934"/>
            <a:ext cx="2352291" cy="319401"/>
          </a:xfrm>
        </p:spPr>
        <p:txBody>
          <a:bodyPr>
            <a:normAutofit fontScale="90000"/>
          </a:bodyPr>
          <a:lstStyle/>
          <a:p>
            <a:pPr algn="l"/>
            <a:r>
              <a:rPr lang="en-US" sz="2000" b="1" dirty="0" err="1" smtClean="0">
                <a:latin typeface="Arial" charset="0"/>
                <a:cs typeface="Arial" charset="0"/>
              </a:rPr>
              <a:t>Suppl</a:t>
            </a:r>
            <a:r>
              <a:rPr lang="en-US" sz="2000" b="1" dirty="0" smtClean="0">
                <a:latin typeface="Arial" charset="0"/>
                <a:cs typeface="Arial" charset="0"/>
              </a:rPr>
              <a:t> Figure 3</a:t>
            </a:r>
            <a:endParaRPr lang="en-US" sz="20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842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93</Words>
  <Application>Microsoft Office PowerPoint</Application>
  <PresentationFormat>On-screen Show (4:3)</PresentationFormat>
  <Paragraphs>8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 Figure 3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stall</dc:creator>
  <cp:lastModifiedBy>Joachim Rudolph</cp:lastModifiedBy>
  <cp:revision>169</cp:revision>
  <cp:lastPrinted>2015-01-13T20:11:25Z</cp:lastPrinted>
  <dcterms:created xsi:type="dcterms:W3CDTF">2014-04-13T22:32:15Z</dcterms:created>
  <dcterms:modified xsi:type="dcterms:W3CDTF">2015-01-19T07:39:28Z</dcterms:modified>
</cp:coreProperties>
</file>